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58" r:id="rId5"/>
    <p:sldId id="261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FEDD283-367A-45DE-82EC-27C0F3BB3D23}" v="4" dt="2026-05-19T13:04:47.55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vana Manjencic" userId="e16540ca-c145-4cf2-a0f4-abdd63d7eb6e" providerId="ADAL" clId="{AC3984FC-050B-4F34-8470-7DB2008C07D5}"/>
    <pc:docChg chg="modSld">
      <pc:chgData name="Ivana Manjencic" userId="e16540ca-c145-4cf2-a0f4-abdd63d7eb6e" providerId="ADAL" clId="{AC3984FC-050B-4F34-8470-7DB2008C07D5}" dt="2026-05-19T13:04:47.553" v="7"/>
      <pc:docMkLst>
        <pc:docMk/>
      </pc:docMkLst>
      <pc:sldChg chg="modSp mod">
        <pc:chgData name="Ivana Manjencic" userId="e16540ca-c145-4cf2-a0f4-abdd63d7eb6e" providerId="ADAL" clId="{AC3984FC-050B-4F34-8470-7DB2008C07D5}" dt="2026-05-19T13:04:31.592" v="3" actId="20577"/>
        <pc:sldMkLst>
          <pc:docMk/>
          <pc:sldMk cId="2649871154" sldId="256"/>
        </pc:sldMkLst>
        <pc:spChg chg="mod">
          <ac:chgData name="Ivana Manjencic" userId="e16540ca-c145-4cf2-a0f4-abdd63d7eb6e" providerId="ADAL" clId="{AC3984FC-050B-4F34-8470-7DB2008C07D5}" dt="2026-05-19T13:04:31.592" v="3" actId="20577"/>
          <ac:spMkLst>
            <pc:docMk/>
            <pc:sldMk cId="2649871154" sldId="256"/>
            <ac:spMk id="4" creationId="{9558F6B6-00E4-4D2D-5AA6-675202F2C57E}"/>
          </ac:spMkLst>
        </pc:spChg>
      </pc:sldChg>
      <pc:sldChg chg="modSp">
        <pc:chgData name="Ivana Manjencic" userId="e16540ca-c145-4cf2-a0f4-abdd63d7eb6e" providerId="ADAL" clId="{AC3984FC-050B-4F34-8470-7DB2008C07D5}" dt="2026-05-19T13:04:37.763" v="4"/>
        <pc:sldMkLst>
          <pc:docMk/>
          <pc:sldMk cId="2543032232" sldId="257"/>
        </pc:sldMkLst>
        <pc:spChg chg="mod">
          <ac:chgData name="Ivana Manjencic" userId="e16540ca-c145-4cf2-a0f4-abdd63d7eb6e" providerId="ADAL" clId="{AC3984FC-050B-4F34-8470-7DB2008C07D5}" dt="2026-05-19T13:04:37.763" v="4"/>
          <ac:spMkLst>
            <pc:docMk/>
            <pc:sldMk cId="2543032232" sldId="257"/>
            <ac:spMk id="2" creationId="{0FAF2C02-DC8E-C146-67AB-E8EFB4AC40DC}"/>
          </ac:spMkLst>
        </pc:spChg>
      </pc:sldChg>
      <pc:sldChg chg="modSp">
        <pc:chgData name="Ivana Manjencic" userId="e16540ca-c145-4cf2-a0f4-abdd63d7eb6e" providerId="ADAL" clId="{AC3984FC-050B-4F34-8470-7DB2008C07D5}" dt="2026-05-19T13:04:44.129" v="6"/>
        <pc:sldMkLst>
          <pc:docMk/>
          <pc:sldMk cId="44252614" sldId="258"/>
        </pc:sldMkLst>
        <pc:spChg chg="mod">
          <ac:chgData name="Ivana Manjencic" userId="e16540ca-c145-4cf2-a0f4-abdd63d7eb6e" providerId="ADAL" clId="{AC3984FC-050B-4F34-8470-7DB2008C07D5}" dt="2026-05-19T13:04:44.129" v="6"/>
          <ac:spMkLst>
            <pc:docMk/>
            <pc:sldMk cId="44252614" sldId="258"/>
            <ac:spMk id="2" creationId="{F085E42F-4AA8-2F22-D40D-9033108F47B8}"/>
          </ac:spMkLst>
        </pc:spChg>
      </pc:sldChg>
      <pc:sldChg chg="modSp">
        <pc:chgData name="Ivana Manjencic" userId="e16540ca-c145-4cf2-a0f4-abdd63d7eb6e" providerId="ADAL" clId="{AC3984FC-050B-4F34-8470-7DB2008C07D5}" dt="2026-05-19T13:04:41.445" v="5"/>
        <pc:sldMkLst>
          <pc:docMk/>
          <pc:sldMk cId="861978151" sldId="260"/>
        </pc:sldMkLst>
        <pc:spChg chg="mod">
          <ac:chgData name="Ivana Manjencic" userId="e16540ca-c145-4cf2-a0f4-abdd63d7eb6e" providerId="ADAL" clId="{AC3984FC-050B-4F34-8470-7DB2008C07D5}" dt="2026-05-19T13:04:41.445" v="5"/>
          <ac:spMkLst>
            <pc:docMk/>
            <pc:sldMk cId="861978151" sldId="260"/>
            <ac:spMk id="2" creationId="{F64ACFC0-943A-1CE6-AA40-53CC1AF7A13A}"/>
          </ac:spMkLst>
        </pc:spChg>
      </pc:sldChg>
      <pc:sldChg chg="modSp">
        <pc:chgData name="Ivana Manjencic" userId="e16540ca-c145-4cf2-a0f4-abdd63d7eb6e" providerId="ADAL" clId="{AC3984FC-050B-4F34-8470-7DB2008C07D5}" dt="2026-05-19T13:04:47.553" v="7"/>
        <pc:sldMkLst>
          <pc:docMk/>
          <pc:sldMk cId="4146547179" sldId="261"/>
        </pc:sldMkLst>
        <pc:spChg chg="mod">
          <ac:chgData name="Ivana Manjencic" userId="e16540ca-c145-4cf2-a0f4-abdd63d7eb6e" providerId="ADAL" clId="{AC3984FC-050B-4F34-8470-7DB2008C07D5}" dt="2026-05-19T13:04:47.553" v="7"/>
          <ac:spMkLst>
            <pc:docMk/>
            <pc:sldMk cId="4146547179" sldId="261"/>
            <ac:spMk id="2" creationId="{3032A44C-7631-D949-40F1-4581368D0E3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8E023D-8339-99D7-FD1C-08008B3F29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3D95D1A-C4A3-8239-FFCD-D28540A510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/>
              <a:t>Click to edit Master subtitle style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87E6E4-D775-B83F-A0BD-C9EEC6A76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50F78-FF54-A0A3-CF20-F1DFD200C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65955D-056A-6D5E-863D-0A9316F68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0078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67E92F-937A-BA15-54D9-07C4BBE528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E40CB2-B323-41BF-7D62-B436C6EE01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8B9E66-E49A-EF45-4479-98822666D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219123-378F-01BD-854A-C2ECD7BF4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CF52F6-5AC2-6CCD-B26D-2463D698A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8848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176FC4-E052-C531-E4A3-0A7D6EC6CF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D320D5-68E2-FF45-0C4D-9124AF2634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5B734F-C54B-A0D8-4C21-72AD3EF46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74619F-2978-609B-034F-0DF2015440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12D240-A5BF-6546-87CF-DA9289DF2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6901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4DC486-6712-D2D2-C672-53549ACF4F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889F7E-44AD-0D87-7619-C675DA75AA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EACC3C-F333-CFF4-0751-ACDAE8A6D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B5F55A-C03A-FD22-544E-E936EF7CE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0CF17C-A81D-E535-58A5-FA38818D6C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223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69A39-16AA-511F-85F7-0EA0C47205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89844D-20F1-7007-245D-853F84AB20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2FE564-9A8D-16FC-09D3-1D9802C98A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290F8D-584D-1EF9-4F17-B784083868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864EBD-522C-47BA-2C3F-BA0B220EDC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4944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D9F099-A380-DCC6-0302-34DB14B6B5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7FB3F6-437A-0D05-D5AE-C72D8FB754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DC7435-84CF-63A8-0E80-B7D0BE9FCC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FFA440-2DFD-EF9B-59B0-348DA1D0D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48ED89-DCB0-7E7F-D26E-70DB4016C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64B03B-EE21-8539-289C-A47254DEC8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9057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C0DA3E-BDED-7702-06C2-071FBDFBCA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16A194-1117-B3A2-F953-0C215B9F44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0BFE7C-1775-033E-C9E1-CBC57D2C28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AF4AB6B-55D2-D278-34EC-556E21528A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C7788D9-58F2-8712-4C0C-57DA86D901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F49A29-2FA7-BDE1-504A-7549A6CCE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542A1A4-8CAA-C384-DF87-37EB0C6E6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4F1A5B-C831-1525-0F2B-0C34134BC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3695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6526DE-D331-9393-5D88-F77A9EBA18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3B55CD0-8DA1-6F0D-DD3F-0366343A3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28F374-FB89-5C25-0B5F-A9041A8AC4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6B11B5-718D-151B-EBC3-20DAD95CB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865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6C57ABA-6914-4633-BCC3-FE60931F73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D3C3A0-C47C-629C-B1C1-00988B6F3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5F3853-447F-8310-A28C-A6923D2E0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6052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1C2E6E-5E37-EF39-F450-544D25631A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E5F206-3EF1-2B5A-BAD5-4186ECB5CD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6B3394-79E6-E5A2-4219-CCAE101B11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2554D0-6437-761D-F3CD-CC2A7718DB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E94DC7-01E2-9D7A-A73E-1CAF768925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7E6031-2479-E321-44E4-811BF210D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2145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DFF64D-D265-0961-4C48-E914160B8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778D7C-6C62-F4DF-161C-B70E184481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1C5A9B-C81D-29DA-04AB-665CC7FFAC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888A4F-6C1D-2F05-4D47-0C5BBB9D4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A4855D-0F18-C2A1-07C4-04965373D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5EFBB8-2C8B-A743-E151-BA14DF741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4622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C38D1B-82CE-2F3F-E894-1C7037D943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E42C73-4FBB-28CA-5377-993798772F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0B0498-2071-4295-ACF4-74FA75F4A6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08C9B90-29DC-4441-90EE-4B6352FD8451}" type="datetimeFigureOut">
              <a:rPr lang="zh-CN" altLang="en-US" smtClean="0"/>
              <a:t>2026/5/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52C641-5686-D03D-3F5F-C4D3D51D66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E0AAD1-0A82-B48F-3996-71ACD385A2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B6724B3-6FF8-4A69-86F9-681B0A5118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262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mp4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9558F6B6-00E4-4D2D-5AA6-675202F2C57E}"/>
              </a:ext>
            </a:extLst>
          </p:cNvPr>
          <p:cNvSpPr txBox="1">
            <a:spLocks/>
          </p:cNvSpPr>
          <p:nvPr/>
        </p:nvSpPr>
        <p:spPr>
          <a:xfrm>
            <a:off x="838200" y="714247"/>
            <a:ext cx="10515600" cy="646332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400" dirty="0"/>
              <a:t>Figure S2 </a:t>
            </a:r>
            <a:r>
              <a:rPr lang="en-US" sz="2400" dirty="0"/>
              <a:t>Internalization of AM6 and Cetuximab by LM2 cell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DB90BDD-0578-D5B1-4A0F-85EB40D246A4}"/>
              </a:ext>
            </a:extLst>
          </p:cNvPr>
          <p:cNvSpPr txBox="1"/>
          <p:nvPr/>
        </p:nvSpPr>
        <p:spPr>
          <a:xfrm>
            <a:off x="1734209" y="5767125"/>
            <a:ext cx="32931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M6</a:t>
            </a:r>
          </a:p>
          <a:p>
            <a:pPr algn="ctr"/>
            <a:r>
              <a:rPr lang="en-US" dirty="0"/>
              <a:t>T = 50 mins to T = 8 h 40 min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B2BD834-1051-FE66-614D-0ABC4D457AB7}"/>
              </a:ext>
            </a:extLst>
          </p:cNvPr>
          <p:cNvSpPr txBox="1"/>
          <p:nvPr/>
        </p:nvSpPr>
        <p:spPr>
          <a:xfrm>
            <a:off x="6776522" y="5776821"/>
            <a:ext cx="40693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tx</a:t>
            </a:r>
          </a:p>
          <a:p>
            <a:pPr algn="ctr"/>
            <a:r>
              <a:rPr lang="en-US" dirty="0"/>
              <a:t>T = 45 mins to T = 8 h 35 mins</a:t>
            </a:r>
          </a:p>
        </p:txBody>
      </p:sp>
      <p:pic>
        <p:nvPicPr>
          <p:cNvPr id="7" name="AM6-647time lapse.jpeg">
            <a:hlinkClick r:id="" action="ppaction://media"/>
            <a:extLst>
              <a:ext uri="{FF2B5EF4-FFF2-40B4-BE49-F238E27FC236}">
                <a16:creationId xmlns:a16="http://schemas.microsoft.com/office/drawing/2014/main" id="{FEC9EF2C-B823-A43B-CB9F-1CDD18E8B19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399592" y="1675295"/>
            <a:ext cx="3962400" cy="3962400"/>
          </a:xfrm>
          <a:prstGeom prst="rect">
            <a:avLst/>
          </a:prstGeom>
        </p:spPr>
      </p:pic>
      <p:pic>
        <p:nvPicPr>
          <p:cNvPr id="8" name="ctx 647">
            <a:hlinkClick r:id="" action="ppaction://media"/>
            <a:extLst>
              <a:ext uri="{FF2B5EF4-FFF2-40B4-BE49-F238E27FC236}">
                <a16:creationId xmlns:a16="http://schemas.microsoft.com/office/drawing/2014/main" id="{A427201A-F640-E0C6-9A17-911844102D28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830008" y="1675295"/>
            <a:ext cx="3962400" cy="396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98711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6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96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9" repeatCount="indefinite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video>
              <p:cMediaNode vol="80000">
                <p:cTn id="10" repeatCount="indefinite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FAF2C02-DC8E-C146-67AB-E8EFB4AC40DC}"/>
              </a:ext>
            </a:extLst>
          </p:cNvPr>
          <p:cNvSpPr txBox="1"/>
          <p:nvPr/>
        </p:nvSpPr>
        <p:spPr>
          <a:xfrm>
            <a:off x="509047" y="348792"/>
            <a:ext cx="7645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4 Effect of endocytic inhibitors on individual endocytic marker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28D2B1A-E3A1-A05B-A70A-E5AAB1FC00CF}"/>
              </a:ext>
            </a:extLst>
          </p:cNvPr>
          <p:cNvSpPr txBox="1"/>
          <p:nvPr/>
        </p:nvSpPr>
        <p:spPr>
          <a:xfrm>
            <a:off x="509047" y="857839"/>
            <a:ext cx="53167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1. The internalization of CME marker transferrin</a:t>
            </a:r>
            <a:endParaRPr lang="zh-CN" altLang="en-US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10B78DB5-9AD1-E75D-4C93-9CD06D153F78}"/>
              </a:ext>
            </a:extLst>
          </p:cNvPr>
          <p:cNvGrpSpPr/>
          <p:nvPr/>
        </p:nvGrpSpPr>
        <p:grpSpPr>
          <a:xfrm>
            <a:off x="0" y="1474847"/>
            <a:ext cx="4822706" cy="4822706"/>
            <a:chOff x="0" y="928573"/>
            <a:chExt cx="4822706" cy="482270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0EF11B1-540C-16AA-5D55-DAEFD54E5B3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928573"/>
              <a:ext cx="4822706" cy="4822706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EF3BB10-D170-4378-69E9-6C09D5EEF0A6}"/>
                </a:ext>
              </a:extLst>
            </p:cNvPr>
            <p:cNvSpPr txBox="1"/>
            <p:nvPr/>
          </p:nvSpPr>
          <p:spPr>
            <a:xfrm>
              <a:off x="7391" y="1013579"/>
              <a:ext cx="15589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/>
                <a:t>3</a:t>
              </a:r>
              <a:r>
                <a:rPr lang="en-US">
                  <a:solidFill>
                    <a:schemeClr val="bg1"/>
                  </a:solidFill>
                </a:rPr>
                <a:t>3 mins</a:t>
              </a:r>
              <a:endParaRPr lang="en-US"/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29B6DD13-C151-B3C9-B9BC-6F9482408B62}"/>
              </a:ext>
            </a:extLst>
          </p:cNvPr>
          <p:cNvGrpSpPr/>
          <p:nvPr/>
        </p:nvGrpSpPr>
        <p:grpSpPr>
          <a:xfrm>
            <a:off x="1127338" y="1474847"/>
            <a:ext cx="4822706" cy="4822706"/>
            <a:chOff x="2047290" y="1244958"/>
            <a:chExt cx="4822706" cy="4822706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9F14533-5208-4F07-2AB0-4DB7927C683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47290" y="1244958"/>
              <a:ext cx="4822706" cy="4822706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77848F9-01E4-848D-C87E-BE2B147CB26F}"/>
                </a:ext>
              </a:extLst>
            </p:cNvPr>
            <p:cNvSpPr txBox="1"/>
            <p:nvPr/>
          </p:nvSpPr>
          <p:spPr>
            <a:xfrm>
              <a:off x="2411353" y="1382911"/>
              <a:ext cx="12012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6 mins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04B7FA30-0529-BBE8-4FC8-C6FBAF4FF373}"/>
              </a:ext>
            </a:extLst>
          </p:cNvPr>
          <p:cNvGrpSpPr/>
          <p:nvPr/>
        </p:nvGrpSpPr>
        <p:grpSpPr>
          <a:xfrm>
            <a:off x="2542796" y="1474847"/>
            <a:ext cx="4822706" cy="4822706"/>
            <a:chOff x="4094579" y="1634578"/>
            <a:chExt cx="4822706" cy="4822706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E6C6D6F2-15B8-007A-817A-7DF0A8E8A29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094579" y="1634578"/>
              <a:ext cx="4822706" cy="4822706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6777DC2-1533-DB74-9409-B1C131A0C4F9}"/>
                </a:ext>
              </a:extLst>
            </p:cNvPr>
            <p:cNvSpPr txBox="1"/>
            <p:nvPr/>
          </p:nvSpPr>
          <p:spPr>
            <a:xfrm>
              <a:off x="4287187" y="1752243"/>
              <a:ext cx="12012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9 mins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CFAB7DEA-0D18-1589-FC4C-3FDE8380F9B1}"/>
              </a:ext>
            </a:extLst>
          </p:cNvPr>
          <p:cNvGrpSpPr/>
          <p:nvPr/>
        </p:nvGrpSpPr>
        <p:grpSpPr>
          <a:xfrm>
            <a:off x="3516106" y="1474847"/>
            <a:ext cx="4822707" cy="4822707"/>
            <a:chOff x="6862605" y="2035293"/>
            <a:chExt cx="4822707" cy="4822707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7106BBD3-443B-CDE8-4A04-D8486CF283C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862605" y="2035293"/>
              <a:ext cx="4822707" cy="4822707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6ED4096-E9B6-A873-4957-02962D1DCADD}"/>
                </a:ext>
              </a:extLst>
            </p:cNvPr>
            <p:cNvSpPr txBox="1"/>
            <p:nvPr/>
          </p:nvSpPr>
          <p:spPr>
            <a:xfrm>
              <a:off x="7212109" y="2181760"/>
              <a:ext cx="11659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12 mins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37947C8F-1C85-5AE7-BA86-E01C6E74D497}"/>
              </a:ext>
            </a:extLst>
          </p:cNvPr>
          <p:cNvGrpSpPr/>
          <p:nvPr/>
        </p:nvGrpSpPr>
        <p:grpSpPr>
          <a:xfrm>
            <a:off x="4921890" y="1474846"/>
            <a:ext cx="4822707" cy="4822707"/>
            <a:chOff x="4954149" y="1608397"/>
            <a:chExt cx="4822707" cy="4822707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176D8E10-34BA-D0EA-41D4-F9A37583316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54149" y="1608397"/>
              <a:ext cx="4822707" cy="4822707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1290AE1-7D09-36AA-CECD-2AD1F9734A5A}"/>
                </a:ext>
              </a:extLst>
            </p:cNvPr>
            <p:cNvSpPr txBox="1"/>
            <p:nvPr/>
          </p:nvSpPr>
          <p:spPr>
            <a:xfrm>
              <a:off x="5096313" y="1728552"/>
              <a:ext cx="1141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20</a:t>
              </a:r>
              <a:r>
                <a:rPr lang="en-US" altLang="zh-CN">
                  <a:solidFill>
                    <a:schemeClr val="bg1"/>
                  </a:solidFill>
                </a:rPr>
                <a:t>mins</a:t>
              </a:r>
              <a:endParaRPr lang="en-US">
                <a:solidFill>
                  <a:schemeClr val="bg1"/>
                </a:solidFill>
              </a:endParaRP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4FF1378F-D8D8-812D-A6A8-E9F0F2DAD313}"/>
              </a:ext>
            </a:extLst>
          </p:cNvPr>
          <p:cNvGrpSpPr/>
          <p:nvPr/>
        </p:nvGrpSpPr>
        <p:grpSpPr>
          <a:xfrm>
            <a:off x="6005543" y="1476362"/>
            <a:ext cx="4822707" cy="4822707"/>
            <a:chOff x="9466150" y="1533446"/>
            <a:chExt cx="4822707" cy="4822707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563F27E3-A870-BCDA-2FBA-F9987A68F36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466150" y="1533446"/>
              <a:ext cx="4822707" cy="4822707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F7D1713-BB0B-932B-736D-7025171BA454}"/>
                </a:ext>
              </a:extLst>
            </p:cNvPr>
            <p:cNvSpPr txBox="1"/>
            <p:nvPr/>
          </p:nvSpPr>
          <p:spPr>
            <a:xfrm>
              <a:off x="9754270" y="1663908"/>
              <a:ext cx="9191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35</a:t>
              </a:r>
              <a:r>
                <a:rPr lang="en-US" altLang="zh-CN">
                  <a:solidFill>
                    <a:schemeClr val="bg1"/>
                  </a:solidFill>
                </a:rPr>
                <a:t>mins</a:t>
              </a:r>
              <a:endParaRPr lang="en-US">
                <a:solidFill>
                  <a:schemeClr val="bg1"/>
                </a:solidFill>
              </a:endParaRP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08C8F724-EDB4-7F6A-F565-3E77164A12A5}"/>
              </a:ext>
            </a:extLst>
          </p:cNvPr>
          <p:cNvGrpSpPr/>
          <p:nvPr/>
        </p:nvGrpSpPr>
        <p:grpSpPr>
          <a:xfrm>
            <a:off x="7368345" y="1473330"/>
            <a:ext cx="4822706" cy="4822705"/>
            <a:chOff x="10396804" y="2035294"/>
            <a:chExt cx="4822706" cy="4822706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0CA7923D-2377-BC0F-A442-BCEE7C12886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396804" y="2035294"/>
              <a:ext cx="4822706" cy="4822706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4D25C19-CB82-DE01-9058-DDAEAE026629}"/>
                </a:ext>
              </a:extLst>
            </p:cNvPr>
            <p:cNvSpPr txBox="1"/>
            <p:nvPr/>
          </p:nvSpPr>
          <p:spPr>
            <a:xfrm>
              <a:off x="10672081" y="2170206"/>
              <a:ext cx="11828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42min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4303223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64ACFC0-943A-1CE6-AA40-53CC1AF7A13A}"/>
              </a:ext>
            </a:extLst>
          </p:cNvPr>
          <p:cNvSpPr txBox="1"/>
          <p:nvPr/>
        </p:nvSpPr>
        <p:spPr>
          <a:xfrm>
            <a:off x="509047" y="348792"/>
            <a:ext cx="7645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4 Effect of endocytic inhibitors on individual endocytic marker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5B42A7C-BBA6-3236-ADE2-387FD879F5DD}"/>
              </a:ext>
            </a:extLst>
          </p:cNvPr>
          <p:cNvSpPr txBox="1"/>
          <p:nvPr/>
        </p:nvSpPr>
        <p:spPr>
          <a:xfrm>
            <a:off x="509046" y="857839"/>
            <a:ext cx="99924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2. The internalization of CME marker transferrin inhibited by 10 ug/ml chlorpromazine</a:t>
            </a:r>
            <a:endParaRPr lang="zh-CN" altLang="en-US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D8928AD-AF7A-F350-30FA-7A9E3F305F02}"/>
              </a:ext>
            </a:extLst>
          </p:cNvPr>
          <p:cNvGrpSpPr/>
          <p:nvPr/>
        </p:nvGrpSpPr>
        <p:grpSpPr>
          <a:xfrm>
            <a:off x="-1" y="1784650"/>
            <a:ext cx="4781167" cy="4705838"/>
            <a:chOff x="0" y="1779351"/>
            <a:chExt cx="4713524" cy="471352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619233C-8D13-DF81-638B-F1C7CDE2B2C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779351"/>
              <a:ext cx="4713524" cy="4713524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3CCE9AE-CAEB-3FF2-2DC4-06055FFD295B}"/>
                </a:ext>
              </a:extLst>
            </p:cNvPr>
            <p:cNvSpPr txBox="1"/>
            <p:nvPr/>
          </p:nvSpPr>
          <p:spPr>
            <a:xfrm>
              <a:off x="110442" y="1821934"/>
              <a:ext cx="8416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chemeClr val="bg1"/>
                  </a:solidFill>
                </a:rPr>
                <a:t>6mins</a:t>
              </a:r>
              <a:endParaRPr lang="en-US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A6F880B9-CEBC-AC7D-C407-BB82D416DBEA}"/>
              </a:ext>
            </a:extLst>
          </p:cNvPr>
          <p:cNvGrpSpPr/>
          <p:nvPr/>
        </p:nvGrpSpPr>
        <p:grpSpPr>
          <a:xfrm>
            <a:off x="978220" y="1781218"/>
            <a:ext cx="4713524" cy="4713524"/>
            <a:chOff x="1382476" y="1463439"/>
            <a:chExt cx="4713524" cy="4713524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351505B-8C50-EB28-0B4E-4658DA8BE44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82476" y="1463439"/>
              <a:ext cx="4713524" cy="4713524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99B1E27-6A46-AC7D-2104-9213DB8DA2D7}"/>
                </a:ext>
              </a:extLst>
            </p:cNvPr>
            <p:cNvSpPr txBox="1"/>
            <p:nvPr/>
          </p:nvSpPr>
          <p:spPr>
            <a:xfrm>
              <a:off x="1654613" y="1511750"/>
              <a:ext cx="10403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9mins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1BA696A9-4E6B-606B-08B6-A8733E7833B5}"/>
              </a:ext>
            </a:extLst>
          </p:cNvPr>
          <p:cNvGrpSpPr/>
          <p:nvPr/>
        </p:nvGrpSpPr>
        <p:grpSpPr>
          <a:xfrm>
            <a:off x="1990405" y="1776964"/>
            <a:ext cx="4713524" cy="4713524"/>
            <a:chOff x="2694943" y="1322931"/>
            <a:chExt cx="4713524" cy="4713524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3F062A2-096D-B2C9-C090-161C3968C9E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694943" y="1322931"/>
              <a:ext cx="4713524" cy="4713524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3A9F146-92A8-13C8-8A3B-C5108C97844D}"/>
                </a:ext>
              </a:extLst>
            </p:cNvPr>
            <p:cNvSpPr txBox="1"/>
            <p:nvPr/>
          </p:nvSpPr>
          <p:spPr>
            <a:xfrm>
              <a:off x="2980325" y="1353706"/>
              <a:ext cx="9521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12mins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6150191-F98C-8D28-6D42-CF8CF33EA0C0}"/>
              </a:ext>
            </a:extLst>
          </p:cNvPr>
          <p:cNvGrpSpPr/>
          <p:nvPr/>
        </p:nvGrpSpPr>
        <p:grpSpPr>
          <a:xfrm>
            <a:off x="3365279" y="1777759"/>
            <a:ext cx="4713524" cy="4713524"/>
            <a:chOff x="6456335" y="1690688"/>
            <a:chExt cx="4713524" cy="4713524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5BB4101D-1CA0-61F8-95EC-0C67D3366D7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456335" y="1690688"/>
              <a:ext cx="4713524" cy="4713524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AB11BDB-329B-2E29-9136-7554C8A7C2C2}"/>
                </a:ext>
              </a:extLst>
            </p:cNvPr>
            <p:cNvSpPr txBox="1"/>
            <p:nvPr/>
          </p:nvSpPr>
          <p:spPr>
            <a:xfrm>
              <a:off x="6693535" y="1733231"/>
              <a:ext cx="9033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15mins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9BCFD721-5C56-B46D-D04E-43008A67D17C}"/>
              </a:ext>
            </a:extLst>
          </p:cNvPr>
          <p:cNvGrpSpPr/>
          <p:nvPr/>
        </p:nvGrpSpPr>
        <p:grpSpPr>
          <a:xfrm>
            <a:off x="4600379" y="1788645"/>
            <a:ext cx="4713524" cy="4713524"/>
            <a:chOff x="5439831" y="1777759"/>
            <a:chExt cx="4713524" cy="4713524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55F55EE2-4E75-7A50-4424-55401D98B85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39831" y="1777759"/>
              <a:ext cx="4713524" cy="4713524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7D8BA0E-2A71-6919-3D07-63819088C635}"/>
                </a:ext>
              </a:extLst>
            </p:cNvPr>
            <p:cNvSpPr txBox="1"/>
            <p:nvPr/>
          </p:nvSpPr>
          <p:spPr>
            <a:xfrm>
              <a:off x="5771627" y="1807609"/>
              <a:ext cx="10309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24mins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6DB89423-9C02-E414-9627-14E26BC2A164}"/>
              </a:ext>
            </a:extLst>
          </p:cNvPr>
          <p:cNvGrpSpPr/>
          <p:nvPr/>
        </p:nvGrpSpPr>
        <p:grpSpPr>
          <a:xfrm>
            <a:off x="5842752" y="1788645"/>
            <a:ext cx="4713524" cy="4713524"/>
            <a:chOff x="6877068" y="1807739"/>
            <a:chExt cx="4713524" cy="4713524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2FCC0E4F-DF1B-36AD-5A28-7E0785D968A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877068" y="1807739"/>
              <a:ext cx="4713524" cy="4713524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F216513-79ED-ABBD-85C2-7E746BF4BC03}"/>
                </a:ext>
              </a:extLst>
            </p:cNvPr>
            <p:cNvSpPr txBox="1"/>
            <p:nvPr/>
          </p:nvSpPr>
          <p:spPr>
            <a:xfrm>
              <a:off x="7122714" y="1837719"/>
              <a:ext cx="10510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36</a:t>
              </a:r>
              <a:r>
                <a:rPr lang="en-US" altLang="zh-CN">
                  <a:solidFill>
                    <a:schemeClr val="bg1"/>
                  </a:solidFill>
                </a:rPr>
                <a:t>mins</a:t>
              </a:r>
              <a:endParaRPr lang="en-US">
                <a:solidFill>
                  <a:schemeClr val="bg1"/>
                </a:solidFill>
              </a:endParaRP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0AB7A279-1360-D2E3-421C-E302EFC07406}"/>
              </a:ext>
            </a:extLst>
          </p:cNvPr>
          <p:cNvGrpSpPr/>
          <p:nvPr/>
        </p:nvGrpSpPr>
        <p:grpSpPr>
          <a:xfrm>
            <a:off x="7175792" y="1785405"/>
            <a:ext cx="4713524" cy="4713524"/>
            <a:chOff x="7434241" y="1807739"/>
            <a:chExt cx="4713524" cy="4713524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12AD1A1A-6974-B466-9AF0-FE7CB488CF5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434241" y="1807739"/>
              <a:ext cx="4713524" cy="4713524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192000D-4EBA-E177-FEC8-FE6BBD9319A3}"/>
                </a:ext>
              </a:extLst>
            </p:cNvPr>
            <p:cNvSpPr txBox="1"/>
            <p:nvPr/>
          </p:nvSpPr>
          <p:spPr>
            <a:xfrm>
              <a:off x="7595685" y="1838516"/>
              <a:ext cx="9158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solidFill>
                    <a:schemeClr val="bg1"/>
                  </a:solidFill>
                </a:rPr>
                <a:t>54min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619781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085E42F-4AA8-2F22-D40D-9033108F47B8}"/>
              </a:ext>
            </a:extLst>
          </p:cNvPr>
          <p:cNvSpPr txBox="1"/>
          <p:nvPr/>
        </p:nvSpPr>
        <p:spPr>
          <a:xfrm>
            <a:off x="509047" y="348792"/>
            <a:ext cx="7645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4 Effect of endocytic inhibitors on individual endocytic marker</a:t>
            </a:r>
            <a:endParaRPr lang="zh-CN" alt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F5EDADF-6216-CB67-2C6D-F36531F4EE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3399" y="1254924"/>
            <a:ext cx="2513649" cy="251364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B20BC8D-8C69-DE4E-005D-48975007B9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07547" y="1254924"/>
            <a:ext cx="2513649" cy="251364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AB878C4-5395-B1DB-3BAB-E613102DBD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62473" y="1254924"/>
            <a:ext cx="2513649" cy="251364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B3F54AE-1C9A-248F-A3A4-83316384848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07007" y="1254924"/>
            <a:ext cx="2513649" cy="251364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6191BC6-C220-6211-4EDF-5D3BB2ED9B4E}"/>
              </a:ext>
            </a:extLst>
          </p:cNvPr>
          <p:cNvSpPr txBox="1"/>
          <p:nvPr/>
        </p:nvSpPr>
        <p:spPr>
          <a:xfrm>
            <a:off x="2493912" y="3741746"/>
            <a:ext cx="757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6</a:t>
            </a:r>
            <a:r>
              <a:rPr lang="en-US" altLang="zh-CN"/>
              <a:t>min</a:t>
            </a:r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5CF8CCD-8678-AE06-B44E-0FF9D289BC6B}"/>
              </a:ext>
            </a:extLst>
          </p:cNvPr>
          <p:cNvSpPr txBox="1"/>
          <p:nvPr/>
        </p:nvSpPr>
        <p:spPr>
          <a:xfrm>
            <a:off x="5164221" y="3741746"/>
            <a:ext cx="1164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12m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9663BC3-845C-5F66-CB1E-D53E731D3A9E}"/>
              </a:ext>
            </a:extLst>
          </p:cNvPr>
          <p:cNvSpPr txBox="1"/>
          <p:nvPr/>
        </p:nvSpPr>
        <p:spPr>
          <a:xfrm>
            <a:off x="7679730" y="3753146"/>
            <a:ext cx="1164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24m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082921D-D711-43CF-8486-2710DCB831A6}"/>
              </a:ext>
            </a:extLst>
          </p:cNvPr>
          <p:cNvSpPr txBox="1"/>
          <p:nvPr/>
        </p:nvSpPr>
        <p:spPr>
          <a:xfrm>
            <a:off x="10415949" y="3738235"/>
            <a:ext cx="1164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60min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A7B97ED3-4130-9776-0DC4-88CB12772C3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73399" y="4069514"/>
            <a:ext cx="2513649" cy="251364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CE775BE-FE9A-31E2-ED5C-E2C9A9626DA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82648" y="4069514"/>
            <a:ext cx="2548940" cy="251364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BBA9628-A5DD-CD59-658D-66892A44248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62473" y="4080914"/>
            <a:ext cx="2513649" cy="251364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604B93D-AD46-8504-992B-F79532DE7B4E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3826"/>
          <a:stretch/>
        </p:blipFill>
        <p:spPr>
          <a:xfrm>
            <a:off x="9507007" y="4069514"/>
            <a:ext cx="2513649" cy="2529513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6D94B9E-84E6-1404-DFEF-8154B0FA831D}"/>
              </a:ext>
            </a:extLst>
          </p:cNvPr>
          <p:cNvSpPr txBox="1"/>
          <p:nvPr/>
        </p:nvSpPr>
        <p:spPr>
          <a:xfrm>
            <a:off x="-10391" y="4840731"/>
            <a:ext cx="20172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Genistein (inh)</a:t>
            </a:r>
          </a:p>
          <a:p>
            <a:r>
              <a:rPr lang="en-US" altLang="zh-CN"/>
              <a:t>+CTB (marker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05436AA-2A46-ECAE-0DF0-AAB385AC41F6}"/>
              </a:ext>
            </a:extLst>
          </p:cNvPr>
          <p:cNvSpPr txBox="1"/>
          <p:nvPr/>
        </p:nvSpPr>
        <p:spPr>
          <a:xfrm>
            <a:off x="60249" y="2327082"/>
            <a:ext cx="14425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CTB (marker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C784DB6-E578-F82A-191A-5F361AB5F7BD}"/>
              </a:ext>
            </a:extLst>
          </p:cNvPr>
          <p:cNvSpPr txBox="1"/>
          <p:nvPr/>
        </p:nvSpPr>
        <p:spPr>
          <a:xfrm>
            <a:off x="509046" y="793401"/>
            <a:ext cx="87480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b. 54ug/ml genistein inhibits the CAV uptake of cholera toxin subunit 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42526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032A44C-7631-D949-40F1-4581368D0E3F}"/>
              </a:ext>
            </a:extLst>
          </p:cNvPr>
          <p:cNvSpPr txBox="1"/>
          <p:nvPr/>
        </p:nvSpPr>
        <p:spPr>
          <a:xfrm>
            <a:off x="509047" y="348792"/>
            <a:ext cx="7645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4 Effect of endocytic inhibitors on individual endocytic marker</a:t>
            </a:r>
            <a:endParaRPr lang="zh-CN" alt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1760526-E1D4-0E9A-517B-E3B71FED8F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8208" y="1848385"/>
            <a:ext cx="3999510" cy="399951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19B8526-F3B6-CB8D-94BF-CD69A8BBC9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41580" y="1848385"/>
            <a:ext cx="4002212" cy="400221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615F083-A824-71E9-5307-AD11F5C1D74A}"/>
              </a:ext>
            </a:extLst>
          </p:cNvPr>
          <p:cNvSpPr txBox="1"/>
          <p:nvPr/>
        </p:nvSpPr>
        <p:spPr>
          <a:xfrm>
            <a:off x="1330016" y="5846544"/>
            <a:ext cx="411148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/>
              <a:t>Dextran 70, no inhibition</a:t>
            </a:r>
          </a:p>
          <a:p>
            <a:r>
              <a:rPr lang="en-US" sz="2000"/>
              <a:t>Imaged at 40 min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D831CC0-AC4E-16DE-2D60-8C38F2CAD135}"/>
              </a:ext>
            </a:extLst>
          </p:cNvPr>
          <p:cNvSpPr txBox="1"/>
          <p:nvPr/>
        </p:nvSpPr>
        <p:spPr>
          <a:xfrm>
            <a:off x="6750499" y="5846544"/>
            <a:ext cx="525557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err="1"/>
              <a:t>EIPA+Dextran</a:t>
            </a:r>
            <a:r>
              <a:rPr lang="en-US" sz="2000" dirty="0"/>
              <a:t> 70, EIPA pretreated 30 mins</a:t>
            </a:r>
          </a:p>
          <a:p>
            <a:r>
              <a:rPr lang="en-US" sz="2000" dirty="0"/>
              <a:t>Imaged at 40 mins after Dextran 70 treatment</a:t>
            </a:r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336E562B-5E5C-2033-41B2-03CD40339C37}"/>
              </a:ext>
            </a:extLst>
          </p:cNvPr>
          <p:cNvSpPr txBox="1">
            <a:spLocks/>
          </p:cNvSpPr>
          <p:nvPr/>
        </p:nvSpPr>
        <p:spPr>
          <a:xfrm>
            <a:off x="838200" y="1007403"/>
            <a:ext cx="10515600" cy="683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c. Macropinocytosis of Dextran 70 is inhibited by 30ug/ml EIPA</a:t>
            </a:r>
          </a:p>
        </p:txBody>
      </p:sp>
    </p:spTree>
    <p:extLst>
      <p:ext uri="{BB962C8B-B14F-4D97-AF65-F5344CB8AC3E}">
        <p14:creationId xmlns:p14="http://schemas.microsoft.com/office/powerpoint/2010/main" val="4146547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86</Words>
  <Application>Microsoft Office PowerPoint</Application>
  <PresentationFormat>Widescreen</PresentationFormat>
  <Paragraphs>38</Paragraphs>
  <Slides>5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等线</vt:lpstr>
      <vt:lpstr>等线 Light</vt:lpstr>
      <vt:lpstr>Arial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ekun Shao</dc:creator>
  <cp:lastModifiedBy>MDPI</cp:lastModifiedBy>
  <cp:revision>2</cp:revision>
  <dcterms:created xsi:type="dcterms:W3CDTF">2024-09-27T17:23:39Z</dcterms:created>
  <dcterms:modified xsi:type="dcterms:W3CDTF">2026-05-19T13:04:54Z</dcterms:modified>
</cp:coreProperties>
</file>